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8" d="100"/>
          <a:sy n="88" d="100"/>
        </p:scale>
        <p:origin x="-2816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stonebloom:Documents:Work:HPAEC%20data:111012_Solomon_fractionation_NB2534_ST575_CDTA.seq:analysis%20w%20new%20number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stonebloom:Documents:Work:HPAEC%20data:111012_Solomon_fractionation_NB2534_ST575_CDTA.seq:analysis%20w%20new%20number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stonebloom:Documents:Work:HPAEC%20data:111012_Solomon_fractionation_NB2534_ST575_CDTA.seq:analysis%20w%20new%20number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stonebloom:Documents:Work:HPAEC%20data:111012_Solomon_fractionation_NB2534_ST575_CDTA.seq:analysis%20w%20new%20number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stonebloom:Documents:Work:HPAEC%20data:111012_Solomon_fractionation_NB2534_ST575_CDTA.seq:analysis%20w%20new%20number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K$152</c:f>
              <c:strCache>
                <c:ptCount val="1"/>
                <c:pt idx="0">
                  <c:v>Control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BQ$113:$BQ$120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0186184088473419</c:v>
                  </c:pt>
                  <c:pt idx="2">
                    <c:v>0.0188080301389232</c:v>
                  </c:pt>
                  <c:pt idx="3">
                    <c:v>0.016841919080769</c:v>
                  </c:pt>
                  <c:pt idx="4">
                    <c:v>0.0337000460621676</c:v>
                  </c:pt>
                  <c:pt idx="5">
                    <c:v>0.00788398280581315</c:v>
                  </c:pt>
                  <c:pt idx="6">
                    <c:v>0.0309667405245554</c:v>
                  </c:pt>
                  <c:pt idx="7">
                    <c:v>0.0314440695829629</c:v>
                  </c:pt>
                </c:numCache>
              </c:numRef>
            </c:plus>
            <c:minus>
              <c:numRef>
                <c:f>Sheet1!$BQ$113:$BQ$120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0186184088473419</c:v>
                  </c:pt>
                  <c:pt idx="2">
                    <c:v>0.0188080301389232</c:v>
                  </c:pt>
                  <c:pt idx="3">
                    <c:v>0.016841919080769</c:v>
                  </c:pt>
                  <c:pt idx="4">
                    <c:v>0.0337000460621676</c:v>
                  </c:pt>
                  <c:pt idx="5">
                    <c:v>0.00788398280581315</c:v>
                  </c:pt>
                  <c:pt idx="6">
                    <c:v>0.0309667405245554</c:v>
                  </c:pt>
                  <c:pt idx="7">
                    <c:v>0.0314440695829629</c:v>
                  </c:pt>
                </c:numCache>
              </c:numRef>
            </c:minus>
          </c:errBars>
          <c:cat>
            <c:strRef>
              <c:f>Sheet1!$BJ$153:$BJ$160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Sheet1!$BK$153:$BK$160</c:f>
              <c:numCache>
                <c:formatCode>General</c:formatCode>
                <c:ptCount val="8"/>
                <c:pt idx="0">
                  <c:v>0.0</c:v>
                </c:pt>
                <c:pt idx="1">
                  <c:v>0.601060030616344</c:v>
                </c:pt>
                <c:pt idx="2">
                  <c:v>4.965689346211885</c:v>
                </c:pt>
                <c:pt idx="3">
                  <c:v>4.811180230234537</c:v>
                </c:pt>
                <c:pt idx="4">
                  <c:v>69.50610179831188</c:v>
                </c:pt>
                <c:pt idx="5">
                  <c:v>15.30369808421232</c:v>
                </c:pt>
                <c:pt idx="6">
                  <c:v>4.225689919737034</c:v>
                </c:pt>
                <c:pt idx="7">
                  <c:v>0.586580590676001</c:v>
                </c:pt>
              </c:numCache>
            </c:numRef>
          </c:val>
        </c:ser>
        <c:ser>
          <c:idx val="2"/>
          <c:order val="1"/>
          <c:tx>
            <c:strRef>
              <c:f>Sheet1!$BM$152</c:f>
              <c:strCache>
                <c:ptCount val="1"/>
                <c:pt idx="0">
                  <c:v>NbPAGR silenced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BQ$137:$BQ$144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0150909690196834</c:v>
                  </c:pt>
                  <c:pt idx="2">
                    <c:v>0.0240277454780669</c:v>
                  </c:pt>
                  <c:pt idx="3">
                    <c:v>0.025665606480968</c:v>
                  </c:pt>
                  <c:pt idx="4">
                    <c:v>0.258145681742199</c:v>
                  </c:pt>
                  <c:pt idx="5">
                    <c:v>0.0724724873295636</c:v>
                  </c:pt>
                  <c:pt idx="6">
                    <c:v>0.0830428681055128</c:v>
                  </c:pt>
                  <c:pt idx="7">
                    <c:v>0.0928091184864239</c:v>
                  </c:pt>
                </c:numCache>
              </c:numRef>
            </c:plus>
            <c:minus>
              <c:numRef>
                <c:f>Sheet1!$BQ$137:$BQ$144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0150909690196834</c:v>
                  </c:pt>
                  <c:pt idx="2">
                    <c:v>0.0240277454780669</c:v>
                  </c:pt>
                  <c:pt idx="3">
                    <c:v>0.025665606480968</c:v>
                  </c:pt>
                  <c:pt idx="4">
                    <c:v>0.258145681742199</c:v>
                  </c:pt>
                  <c:pt idx="5">
                    <c:v>0.0724724873295636</c:v>
                  </c:pt>
                  <c:pt idx="6">
                    <c:v>0.0830428681055128</c:v>
                  </c:pt>
                  <c:pt idx="7">
                    <c:v>0.0928091184864239</c:v>
                  </c:pt>
                </c:numCache>
              </c:numRef>
            </c:minus>
          </c:errBars>
          <c:cat>
            <c:strRef>
              <c:f>Sheet1!$BJ$153:$BJ$160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Sheet1!$BM$153:$BM$160</c:f>
              <c:numCache>
                <c:formatCode>General</c:formatCode>
                <c:ptCount val="8"/>
                <c:pt idx="0">
                  <c:v>0.0</c:v>
                </c:pt>
                <c:pt idx="1">
                  <c:v>0.590903305947743</c:v>
                </c:pt>
                <c:pt idx="2">
                  <c:v>5.01566503058913</c:v>
                </c:pt>
                <c:pt idx="3">
                  <c:v>4.89934119243197</c:v>
                </c:pt>
                <c:pt idx="4">
                  <c:v>69.66349435045787</c:v>
                </c:pt>
                <c:pt idx="5">
                  <c:v>15.24350897801893</c:v>
                </c:pt>
                <c:pt idx="6">
                  <c:v>4.17513937479757</c:v>
                </c:pt>
                <c:pt idx="7">
                  <c:v>0.5492636903420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2141800"/>
        <c:axId val="2144033992"/>
      </c:barChart>
      <c:catAx>
        <c:axId val="2142141800"/>
        <c:scaling>
          <c:orientation val="minMax"/>
        </c:scaling>
        <c:delete val="0"/>
        <c:axPos val="b"/>
        <c:majorTickMark val="out"/>
        <c:minorTickMark val="none"/>
        <c:tickLblPos val="nextTo"/>
        <c:crossAx val="2144033992"/>
        <c:crosses val="autoZero"/>
        <c:auto val="1"/>
        <c:lblAlgn val="ctr"/>
        <c:lblOffset val="100"/>
        <c:noMultiLvlLbl val="0"/>
      </c:catAx>
      <c:valAx>
        <c:axId val="21440339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142141800"/>
        <c:crosses val="autoZero"/>
        <c:crossBetween val="between"/>
      </c:valAx>
    </c:plotArea>
    <c:legend>
      <c:legendPos val="l"/>
      <c:layout>
        <c:manualLayout>
          <c:xMode val="edge"/>
          <c:yMode val="edge"/>
          <c:x val="0.152777777777778"/>
          <c:y val="0.13120406824147"/>
          <c:w val="0.256617089530475"/>
          <c:h val="0.348702974628172"/>
        </c:manualLayout>
      </c:layout>
      <c:overlay val="1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Z$152</c:f>
              <c:strCache>
                <c:ptCount val="1"/>
                <c:pt idx="0">
                  <c:v>Control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AF$113:$AF$120</c:f>
                <c:numCache>
                  <c:formatCode>General</c:formatCode>
                  <c:ptCount val="8"/>
                  <c:pt idx="0">
                    <c:v>0.00945374956968212</c:v>
                  </c:pt>
                  <c:pt idx="1">
                    <c:v>1.178003413852996</c:v>
                  </c:pt>
                  <c:pt idx="2">
                    <c:v>0.640442286747919</c:v>
                  </c:pt>
                  <c:pt idx="3">
                    <c:v>1.628140330221183</c:v>
                  </c:pt>
                  <c:pt idx="4">
                    <c:v>0.352695779842242</c:v>
                  </c:pt>
                  <c:pt idx="5">
                    <c:v>0.212065294621743</c:v>
                  </c:pt>
                  <c:pt idx="6">
                    <c:v>0.728323056928148</c:v>
                  </c:pt>
                  <c:pt idx="7">
                    <c:v>0.220050098803323</c:v>
                  </c:pt>
                </c:numCache>
              </c:numRef>
            </c:plus>
            <c:minus>
              <c:numRef>
                <c:f>Sheet1!$AF$113:$AF$120</c:f>
                <c:numCache>
                  <c:formatCode>General</c:formatCode>
                  <c:ptCount val="8"/>
                  <c:pt idx="0">
                    <c:v>0.00945374956968212</c:v>
                  </c:pt>
                  <c:pt idx="1">
                    <c:v>1.178003413852996</c:v>
                  </c:pt>
                  <c:pt idx="2">
                    <c:v>0.640442286747919</c:v>
                  </c:pt>
                  <c:pt idx="3">
                    <c:v>1.628140330221183</c:v>
                  </c:pt>
                  <c:pt idx="4">
                    <c:v>0.352695779842242</c:v>
                  </c:pt>
                  <c:pt idx="5">
                    <c:v>0.212065294621743</c:v>
                  </c:pt>
                  <c:pt idx="6">
                    <c:v>0.728323056928148</c:v>
                  </c:pt>
                  <c:pt idx="7">
                    <c:v>0.220050098803323</c:v>
                  </c:pt>
                </c:numCache>
              </c:numRef>
            </c:minus>
          </c:errBars>
          <c:cat>
            <c:strRef>
              <c:f>Sheet1!$Y$153:$Y$160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Sheet1!$Z$153:$Z$160</c:f>
              <c:numCache>
                <c:formatCode>General</c:formatCode>
                <c:ptCount val="8"/>
                <c:pt idx="0">
                  <c:v>0.325205178033592</c:v>
                </c:pt>
                <c:pt idx="1">
                  <c:v>14.55908495097006</c:v>
                </c:pt>
                <c:pt idx="2">
                  <c:v>15.38667458399131</c:v>
                </c:pt>
                <c:pt idx="3">
                  <c:v>39.56905679430812</c:v>
                </c:pt>
                <c:pt idx="4">
                  <c:v>1.20967570725304</c:v>
                </c:pt>
                <c:pt idx="5">
                  <c:v>1.086085532184105</c:v>
                </c:pt>
                <c:pt idx="6">
                  <c:v>25.41667446824048</c:v>
                </c:pt>
                <c:pt idx="7">
                  <c:v>2.447542785019275</c:v>
                </c:pt>
              </c:numCache>
            </c:numRef>
          </c:val>
        </c:ser>
        <c:ser>
          <c:idx val="2"/>
          <c:order val="1"/>
          <c:tx>
            <c:strRef>
              <c:f>Sheet1!$AB$152</c:f>
              <c:strCache>
                <c:ptCount val="1"/>
                <c:pt idx="0">
                  <c:v>NbPAGR silenced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AF$137:$AF$144</c:f>
                <c:numCache>
                  <c:formatCode>General</c:formatCode>
                  <c:ptCount val="8"/>
                  <c:pt idx="0">
                    <c:v>0.0128751647554298</c:v>
                  </c:pt>
                  <c:pt idx="1">
                    <c:v>1.126471305721273</c:v>
                  </c:pt>
                  <c:pt idx="2">
                    <c:v>0.541285146793214</c:v>
                  </c:pt>
                  <c:pt idx="3">
                    <c:v>1.378444760808438</c:v>
                  </c:pt>
                  <c:pt idx="4">
                    <c:v>0.130186169605178</c:v>
                  </c:pt>
                  <c:pt idx="5">
                    <c:v>0.0920220108850236</c:v>
                  </c:pt>
                  <c:pt idx="6">
                    <c:v>1.413448482769573</c:v>
                  </c:pt>
                  <c:pt idx="7">
                    <c:v>0.253292153440536</c:v>
                  </c:pt>
                </c:numCache>
              </c:numRef>
            </c:plus>
            <c:minus>
              <c:numRef>
                <c:f>Sheet1!$AF$137:$AF$144</c:f>
                <c:numCache>
                  <c:formatCode>General</c:formatCode>
                  <c:ptCount val="8"/>
                  <c:pt idx="0">
                    <c:v>0.0128751647554298</c:v>
                  </c:pt>
                  <c:pt idx="1">
                    <c:v>1.126471305721273</c:v>
                  </c:pt>
                  <c:pt idx="2">
                    <c:v>0.541285146793214</c:v>
                  </c:pt>
                  <c:pt idx="3">
                    <c:v>1.378444760808438</c:v>
                  </c:pt>
                  <c:pt idx="4">
                    <c:v>0.130186169605178</c:v>
                  </c:pt>
                  <c:pt idx="5">
                    <c:v>0.0920220108850236</c:v>
                  </c:pt>
                  <c:pt idx="6">
                    <c:v>1.413448482769573</c:v>
                  </c:pt>
                  <c:pt idx="7">
                    <c:v>0.253292153440536</c:v>
                  </c:pt>
                </c:numCache>
              </c:numRef>
            </c:minus>
          </c:errBars>
          <c:cat>
            <c:strRef>
              <c:f>Sheet1!$Y$153:$Y$160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Sheet1!$AB$153:$AB$160</c:f>
              <c:numCache>
                <c:formatCode>General</c:formatCode>
                <c:ptCount val="8"/>
                <c:pt idx="0">
                  <c:v>0.358305769794681</c:v>
                </c:pt>
                <c:pt idx="1">
                  <c:v>16.45151375145794</c:v>
                </c:pt>
                <c:pt idx="2">
                  <c:v>13.59661037884924</c:v>
                </c:pt>
                <c:pt idx="3">
                  <c:v>31.84072412023778</c:v>
                </c:pt>
                <c:pt idx="4">
                  <c:v>1.060492379924822</c:v>
                </c:pt>
                <c:pt idx="5">
                  <c:v>0.952107488017012</c:v>
                </c:pt>
                <c:pt idx="6">
                  <c:v>33.5082449601115</c:v>
                </c:pt>
                <c:pt idx="7">
                  <c:v>2.2320011516070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0760488"/>
        <c:axId val="2140725848"/>
      </c:barChart>
      <c:catAx>
        <c:axId val="2140760488"/>
        <c:scaling>
          <c:orientation val="minMax"/>
        </c:scaling>
        <c:delete val="0"/>
        <c:axPos val="b"/>
        <c:majorTickMark val="out"/>
        <c:minorTickMark val="none"/>
        <c:tickLblPos val="nextTo"/>
        <c:crossAx val="2140725848"/>
        <c:crosses val="autoZero"/>
        <c:auto val="1"/>
        <c:lblAlgn val="ctr"/>
        <c:lblOffset val="100"/>
        <c:noMultiLvlLbl val="0"/>
      </c:catAx>
      <c:valAx>
        <c:axId val="21407258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140760488"/>
        <c:crosses val="autoZero"/>
        <c:crossBetween val="between"/>
      </c:valAx>
    </c:plotArea>
    <c:legend>
      <c:legendPos val="l"/>
      <c:layout>
        <c:manualLayout>
          <c:xMode val="edge"/>
          <c:yMode val="edge"/>
          <c:x val="0.138888888888889"/>
          <c:y val="0.0687040682414698"/>
          <c:w val="0.275135608048994"/>
          <c:h val="0.307036307961505"/>
        </c:manualLayout>
      </c:layout>
      <c:overlay val="1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D$152</c:f>
              <c:strCache>
                <c:ptCount val="1"/>
                <c:pt idx="0">
                  <c:v>Control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Macintosh HD:Users:sstonebloom:Documents:Work:HPAEC data:111012_Solomon_fractionation_NB2534_ST575_CDTA.seq:[analysis.xlsx]Sheet2'!$J$113:$J$120</c:f>
                <c:numCache>
                  <c:formatCode>General</c:formatCode>
                  <c:ptCount val="8"/>
                  <c:pt idx="0">
                    <c:v>0.039156615143627</c:v>
                  </c:pt>
                  <c:pt idx="1">
                    <c:v>0.838534840661034</c:v>
                  </c:pt>
                  <c:pt idx="2">
                    <c:v>0.484051702126962</c:v>
                  </c:pt>
                  <c:pt idx="3">
                    <c:v>1.125933041597398</c:v>
                  </c:pt>
                  <c:pt idx="4">
                    <c:v>0.228463056459385</c:v>
                  </c:pt>
                  <c:pt idx="5">
                    <c:v>0.325895507621364</c:v>
                  </c:pt>
                  <c:pt idx="6">
                    <c:v>1.220088402615206</c:v>
                  </c:pt>
                  <c:pt idx="7">
                    <c:v>0.0747049243257612</c:v>
                  </c:pt>
                </c:numCache>
              </c:numRef>
            </c:plus>
            <c:minus>
              <c:numRef>
                <c:f>'Macintosh HD:Users:sstonebloom:Documents:Work:HPAEC data:111012_Solomon_fractionation_NB2534_ST575_CDTA.seq:[analysis.xlsx]Sheet2'!$J$113:$J$120</c:f>
                <c:numCache>
                  <c:formatCode>General</c:formatCode>
                  <c:ptCount val="8"/>
                  <c:pt idx="0">
                    <c:v>0.039156615143627</c:v>
                  </c:pt>
                  <c:pt idx="1">
                    <c:v>0.838534840661034</c:v>
                  </c:pt>
                  <c:pt idx="2">
                    <c:v>0.484051702126962</c:v>
                  </c:pt>
                  <c:pt idx="3">
                    <c:v>1.125933041597398</c:v>
                  </c:pt>
                  <c:pt idx="4">
                    <c:v>0.228463056459385</c:v>
                  </c:pt>
                  <c:pt idx="5">
                    <c:v>0.325895507621364</c:v>
                  </c:pt>
                  <c:pt idx="6">
                    <c:v>1.220088402615206</c:v>
                  </c:pt>
                  <c:pt idx="7">
                    <c:v>0.0747049243257612</c:v>
                  </c:pt>
                </c:numCache>
              </c:numRef>
            </c:minus>
          </c:errBars>
          <c:cat>
            <c:strRef>
              <c:f>Sheet1!$C$153:$C$160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Sheet1!$D$153:$D$160</c:f>
              <c:numCache>
                <c:formatCode>General</c:formatCode>
                <c:ptCount val="8"/>
                <c:pt idx="0">
                  <c:v>0.363772259344337</c:v>
                </c:pt>
                <c:pt idx="1">
                  <c:v>10.97589231950268</c:v>
                </c:pt>
                <c:pt idx="2">
                  <c:v>10.74749928503351</c:v>
                </c:pt>
                <c:pt idx="3">
                  <c:v>25.99210212148785</c:v>
                </c:pt>
                <c:pt idx="4">
                  <c:v>2.849254452126485</c:v>
                </c:pt>
                <c:pt idx="5">
                  <c:v>1.933815702958389</c:v>
                </c:pt>
                <c:pt idx="6">
                  <c:v>45.67788249185777</c:v>
                </c:pt>
                <c:pt idx="7">
                  <c:v>1.550724432525067</c:v>
                </c:pt>
              </c:numCache>
            </c:numRef>
          </c:val>
        </c:ser>
        <c:ser>
          <c:idx val="2"/>
          <c:order val="1"/>
          <c:tx>
            <c:strRef>
              <c:f>Sheet1!$F$152</c:f>
              <c:strCache>
                <c:ptCount val="1"/>
                <c:pt idx="0">
                  <c:v>NbPAGR silenced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Macintosh HD:Users:sstonebloom:Documents:Work:HPAEC data:111012_Solomon_fractionation_NB2534_ST575_CDTA.seq:[analysis.xlsx]Sheet2'!$J$137:$J$144</c:f>
                <c:numCache>
                  <c:formatCode>General</c:formatCode>
                  <c:ptCount val="8"/>
                  <c:pt idx="0">
                    <c:v>0.0106937411269873</c:v>
                  </c:pt>
                  <c:pt idx="1">
                    <c:v>0.581944129341184</c:v>
                  </c:pt>
                  <c:pt idx="2">
                    <c:v>0.737731349597606</c:v>
                  </c:pt>
                  <c:pt idx="3">
                    <c:v>1.526216917407127</c:v>
                  </c:pt>
                  <c:pt idx="4">
                    <c:v>0.539272049092</c:v>
                  </c:pt>
                  <c:pt idx="5">
                    <c:v>0.198261078223611</c:v>
                  </c:pt>
                  <c:pt idx="6">
                    <c:v>2.898098057475812</c:v>
                  </c:pt>
                  <c:pt idx="7">
                    <c:v>0.266246377983274</c:v>
                  </c:pt>
                </c:numCache>
              </c:numRef>
            </c:plus>
            <c:minus>
              <c:numRef>
                <c:f>'Macintosh HD:Users:sstonebloom:Documents:Work:HPAEC data:111012_Solomon_fractionation_NB2534_ST575_CDTA.seq:[analysis.xlsx]Sheet2'!$J$137:$J$144</c:f>
                <c:numCache>
                  <c:formatCode>General</c:formatCode>
                  <c:ptCount val="8"/>
                  <c:pt idx="0">
                    <c:v>0.0106937411269873</c:v>
                  </c:pt>
                  <c:pt idx="1">
                    <c:v>0.581944129341184</c:v>
                  </c:pt>
                  <c:pt idx="2">
                    <c:v>0.737731349597606</c:v>
                  </c:pt>
                  <c:pt idx="3">
                    <c:v>1.526216917407127</c:v>
                  </c:pt>
                  <c:pt idx="4">
                    <c:v>0.539272049092</c:v>
                  </c:pt>
                  <c:pt idx="5">
                    <c:v>0.198261078223611</c:v>
                  </c:pt>
                  <c:pt idx="6">
                    <c:v>2.898098057475812</c:v>
                  </c:pt>
                  <c:pt idx="7">
                    <c:v>0.266246377983274</c:v>
                  </c:pt>
                </c:numCache>
              </c:numRef>
            </c:minus>
          </c:errBars>
          <c:cat>
            <c:strRef>
              <c:f>Sheet1!$C$153:$C$160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Sheet1!$F$153:$F$160</c:f>
              <c:numCache>
                <c:formatCode>General</c:formatCode>
                <c:ptCount val="8"/>
                <c:pt idx="0">
                  <c:v>0.213228570107608</c:v>
                </c:pt>
                <c:pt idx="1">
                  <c:v>6.977702200839791</c:v>
                </c:pt>
                <c:pt idx="2">
                  <c:v>6.71438244893289</c:v>
                </c:pt>
                <c:pt idx="3">
                  <c:v>12.88262981698171</c:v>
                </c:pt>
                <c:pt idx="4">
                  <c:v>2.683120597554053</c:v>
                </c:pt>
                <c:pt idx="5">
                  <c:v>2.131924079858524</c:v>
                </c:pt>
                <c:pt idx="6">
                  <c:v>67.31055894223678</c:v>
                </c:pt>
                <c:pt idx="7">
                  <c:v>1.0864533434886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7647864"/>
        <c:axId val="-2137645848"/>
      </c:barChart>
      <c:catAx>
        <c:axId val="-2137647864"/>
        <c:scaling>
          <c:orientation val="minMax"/>
        </c:scaling>
        <c:delete val="0"/>
        <c:axPos val="b"/>
        <c:majorTickMark val="out"/>
        <c:minorTickMark val="none"/>
        <c:tickLblPos val="nextTo"/>
        <c:crossAx val="-2137645848"/>
        <c:crosses val="autoZero"/>
        <c:auto val="1"/>
        <c:lblAlgn val="ctr"/>
        <c:lblOffset val="100"/>
        <c:noMultiLvlLbl val="0"/>
      </c:catAx>
      <c:valAx>
        <c:axId val="-21376458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2137647864"/>
        <c:crosses val="autoZero"/>
        <c:crossBetween val="between"/>
      </c:valAx>
    </c:plotArea>
    <c:legend>
      <c:legendPos val="l"/>
      <c:layout>
        <c:manualLayout>
          <c:xMode val="edge"/>
          <c:yMode val="edge"/>
          <c:x val="0.143518518518519"/>
          <c:y val="0.0874124718734744"/>
          <c:w val="0.265876348789735"/>
          <c:h val="0.318413779300997"/>
        </c:manualLayout>
      </c:layout>
      <c:overlay val="1"/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O$152</c:f>
              <c:strCache>
                <c:ptCount val="1"/>
                <c:pt idx="0">
                  <c:v>Control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AU$113:$AU$120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162973727767491</c:v>
                  </c:pt>
                  <c:pt idx="2">
                    <c:v>0.246796218182254</c:v>
                  </c:pt>
                  <c:pt idx="3">
                    <c:v>0.62170573407411</c:v>
                  </c:pt>
                  <c:pt idx="4">
                    <c:v>2.281577360648648</c:v>
                  </c:pt>
                  <c:pt idx="5">
                    <c:v>0.279557669052285</c:v>
                  </c:pt>
                  <c:pt idx="6">
                    <c:v>0.994985151009999</c:v>
                  </c:pt>
                  <c:pt idx="7">
                    <c:v>0.533221908323792</c:v>
                  </c:pt>
                </c:numCache>
              </c:numRef>
            </c:plus>
            <c:minus>
              <c:numRef>
                <c:f>Sheet1!$AU$113:$AU$120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162973727767491</c:v>
                  </c:pt>
                  <c:pt idx="2">
                    <c:v>0.246796218182254</c:v>
                  </c:pt>
                  <c:pt idx="3">
                    <c:v>0.62170573407411</c:v>
                  </c:pt>
                  <c:pt idx="4">
                    <c:v>2.281577360648648</c:v>
                  </c:pt>
                  <c:pt idx="5">
                    <c:v>0.279557669052285</c:v>
                  </c:pt>
                  <c:pt idx="6">
                    <c:v>0.994985151009999</c:v>
                  </c:pt>
                  <c:pt idx="7">
                    <c:v>0.533221908323792</c:v>
                  </c:pt>
                </c:numCache>
              </c:numRef>
            </c:minus>
          </c:errBars>
          <c:cat>
            <c:strRef>
              <c:f>Sheet1!$AN$153:$AN$160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Sheet1!$AO$153:$AO$160</c:f>
              <c:numCache>
                <c:formatCode>General</c:formatCode>
                <c:ptCount val="8"/>
                <c:pt idx="0">
                  <c:v>0.0</c:v>
                </c:pt>
                <c:pt idx="1">
                  <c:v>0.968610072952857</c:v>
                </c:pt>
                <c:pt idx="2">
                  <c:v>2.123346314069124</c:v>
                </c:pt>
                <c:pt idx="3">
                  <c:v>4.628000458969105</c:v>
                </c:pt>
                <c:pt idx="4">
                  <c:v>72.3807955360665</c:v>
                </c:pt>
                <c:pt idx="5">
                  <c:v>3.726163745991323</c:v>
                </c:pt>
                <c:pt idx="6">
                  <c:v>12.68084781484801</c:v>
                </c:pt>
                <c:pt idx="7">
                  <c:v>3.492236057102685</c:v>
                </c:pt>
              </c:numCache>
            </c:numRef>
          </c:val>
        </c:ser>
        <c:ser>
          <c:idx val="2"/>
          <c:order val="1"/>
          <c:tx>
            <c:strRef>
              <c:f>Sheet1!$AQ$152</c:f>
              <c:strCache>
                <c:ptCount val="1"/>
                <c:pt idx="0">
                  <c:v>NbPAGR silenced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AU$137:$AU$144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0846122887767934</c:v>
                  </c:pt>
                  <c:pt idx="2">
                    <c:v>0.283770763890306</c:v>
                  </c:pt>
                  <c:pt idx="3">
                    <c:v>0.353868166111134</c:v>
                  </c:pt>
                  <c:pt idx="4">
                    <c:v>3.286002541428996</c:v>
                  </c:pt>
                  <c:pt idx="5">
                    <c:v>0.707996340931926</c:v>
                  </c:pt>
                  <c:pt idx="6">
                    <c:v>1.76537741903531</c:v>
                  </c:pt>
                  <c:pt idx="7">
                    <c:v>0.223182745328215</c:v>
                  </c:pt>
                </c:numCache>
              </c:numRef>
            </c:plus>
            <c:minus>
              <c:numRef>
                <c:f>Sheet1!$AU$137:$AU$144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0846122887767934</c:v>
                  </c:pt>
                  <c:pt idx="2">
                    <c:v>0.283770763890306</c:v>
                  </c:pt>
                  <c:pt idx="3">
                    <c:v>0.353868166111134</c:v>
                  </c:pt>
                  <c:pt idx="4">
                    <c:v>3.286002541428996</c:v>
                  </c:pt>
                  <c:pt idx="5">
                    <c:v>0.707996340931926</c:v>
                  </c:pt>
                  <c:pt idx="6">
                    <c:v>1.76537741903531</c:v>
                  </c:pt>
                  <c:pt idx="7">
                    <c:v>0.223182745328215</c:v>
                  </c:pt>
                </c:numCache>
              </c:numRef>
            </c:minus>
          </c:errBars>
          <c:cat>
            <c:strRef>
              <c:f>Sheet1!$AN$153:$AN$160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Sheet1!$AQ$153:$AQ$160</c:f>
              <c:numCache>
                <c:formatCode>General</c:formatCode>
                <c:ptCount val="8"/>
                <c:pt idx="0">
                  <c:v>0.0</c:v>
                </c:pt>
                <c:pt idx="1">
                  <c:v>0.454266818565337</c:v>
                </c:pt>
                <c:pt idx="2">
                  <c:v>1.660108708564628</c:v>
                </c:pt>
                <c:pt idx="3">
                  <c:v>2.387633899244896</c:v>
                </c:pt>
                <c:pt idx="4">
                  <c:v>82.77966777773701</c:v>
                </c:pt>
                <c:pt idx="5">
                  <c:v>4.853463011828841</c:v>
                </c:pt>
                <c:pt idx="6">
                  <c:v>5.868385935572315</c:v>
                </c:pt>
                <c:pt idx="7">
                  <c:v>1.9964738484869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4434520"/>
        <c:axId val="2082092952"/>
      </c:barChart>
      <c:catAx>
        <c:axId val="2114434520"/>
        <c:scaling>
          <c:orientation val="minMax"/>
        </c:scaling>
        <c:delete val="0"/>
        <c:axPos val="b"/>
        <c:majorTickMark val="out"/>
        <c:minorTickMark val="none"/>
        <c:tickLblPos val="nextTo"/>
        <c:crossAx val="2082092952"/>
        <c:crosses val="autoZero"/>
        <c:auto val="1"/>
        <c:lblAlgn val="ctr"/>
        <c:lblOffset val="100"/>
        <c:noMultiLvlLbl val="0"/>
      </c:catAx>
      <c:valAx>
        <c:axId val="20820929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114434520"/>
        <c:crosses val="autoZero"/>
        <c:crossBetween val="between"/>
      </c:valAx>
    </c:plotArea>
    <c:legend>
      <c:legendPos val="l"/>
      <c:layout>
        <c:manualLayout>
          <c:xMode val="edge"/>
          <c:yMode val="edge"/>
          <c:x val="0.175925925925926"/>
          <c:y val="0.103426290463692"/>
          <c:w val="0.265876348789735"/>
          <c:h val="0.272314085739283"/>
        </c:manualLayout>
      </c:layout>
      <c:overlay val="1"/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Z$152</c:f>
              <c:strCache>
                <c:ptCount val="1"/>
                <c:pt idx="0">
                  <c:v>Control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BF$113:$BF$120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011692633749245</c:v>
                  </c:pt>
                  <c:pt idx="2">
                    <c:v>0.450799855280834</c:v>
                  </c:pt>
                  <c:pt idx="3">
                    <c:v>0.541448885062211</c:v>
                  </c:pt>
                  <c:pt idx="4">
                    <c:v>3.416921870390073</c:v>
                  </c:pt>
                  <c:pt idx="5">
                    <c:v>1.287025089890758</c:v>
                  </c:pt>
                  <c:pt idx="6">
                    <c:v>1.615830497009311</c:v>
                  </c:pt>
                  <c:pt idx="7">
                    <c:v>0.196216637856692</c:v>
                  </c:pt>
                </c:numCache>
              </c:numRef>
            </c:plus>
            <c:minus>
              <c:numRef>
                <c:f>Sheet1!$BF$113:$BF$120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011692633749245</c:v>
                  </c:pt>
                  <c:pt idx="2">
                    <c:v>0.450799855280834</c:v>
                  </c:pt>
                  <c:pt idx="3">
                    <c:v>0.541448885062211</c:v>
                  </c:pt>
                  <c:pt idx="4">
                    <c:v>3.416921870390073</c:v>
                  </c:pt>
                  <c:pt idx="5">
                    <c:v>1.287025089890758</c:v>
                  </c:pt>
                  <c:pt idx="6">
                    <c:v>1.615830497009311</c:v>
                  </c:pt>
                  <c:pt idx="7">
                    <c:v>0.196216637856692</c:v>
                  </c:pt>
                </c:numCache>
              </c:numRef>
            </c:minus>
          </c:errBars>
          <c:cat>
            <c:strRef>
              <c:f>Sheet1!$AY$153:$AY$160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Sheet1!$AZ$153:$AZ$160</c:f>
              <c:numCache>
                <c:formatCode>General</c:formatCode>
                <c:ptCount val="8"/>
                <c:pt idx="0">
                  <c:v>0.0</c:v>
                </c:pt>
                <c:pt idx="1">
                  <c:v>0.75981376063574</c:v>
                </c:pt>
                <c:pt idx="2">
                  <c:v>3.616851915643238</c:v>
                </c:pt>
                <c:pt idx="3">
                  <c:v>4.455353515692033</c:v>
                </c:pt>
                <c:pt idx="4">
                  <c:v>73.7959210936373</c:v>
                </c:pt>
                <c:pt idx="5">
                  <c:v>10.99740186969746</c:v>
                </c:pt>
                <c:pt idx="6">
                  <c:v>5.688854558923293</c:v>
                </c:pt>
                <c:pt idx="7">
                  <c:v>0.914404381027858</c:v>
                </c:pt>
              </c:numCache>
            </c:numRef>
          </c:val>
        </c:ser>
        <c:ser>
          <c:idx val="2"/>
          <c:order val="1"/>
          <c:tx>
            <c:strRef>
              <c:f>Sheet1!$BB$152</c:f>
              <c:strCache>
                <c:ptCount val="1"/>
                <c:pt idx="0">
                  <c:v>NbPAGR silenced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BF$137:$BF$144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0124970631283757</c:v>
                  </c:pt>
                  <c:pt idx="2">
                    <c:v>0.0198282507497677</c:v>
                  </c:pt>
                  <c:pt idx="3">
                    <c:v>0.0293723715063575</c:v>
                  </c:pt>
                  <c:pt idx="4">
                    <c:v>0.109321950498945</c:v>
                  </c:pt>
                  <c:pt idx="5">
                    <c:v>0.0225329957286183</c:v>
                  </c:pt>
                  <c:pt idx="6">
                    <c:v>0.108286590494969</c:v>
                  </c:pt>
                  <c:pt idx="7">
                    <c:v>0.044979184462528</c:v>
                  </c:pt>
                </c:numCache>
              </c:numRef>
            </c:plus>
            <c:minus>
              <c:numRef>
                <c:f>Sheet1!$BF$137:$BF$144</c:f>
                <c:numCache>
                  <c:formatCode>General</c:formatCode>
                  <c:ptCount val="8"/>
                  <c:pt idx="0">
                    <c:v>0.0</c:v>
                  </c:pt>
                  <c:pt idx="1">
                    <c:v>0.0124970631283757</c:v>
                  </c:pt>
                  <c:pt idx="2">
                    <c:v>0.0198282507497677</c:v>
                  </c:pt>
                  <c:pt idx="3">
                    <c:v>0.0293723715063575</c:v>
                  </c:pt>
                  <c:pt idx="4">
                    <c:v>0.109321950498945</c:v>
                  </c:pt>
                  <c:pt idx="5">
                    <c:v>0.0225329957286183</c:v>
                  </c:pt>
                  <c:pt idx="6">
                    <c:v>0.108286590494969</c:v>
                  </c:pt>
                  <c:pt idx="7">
                    <c:v>0.044979184462528</c:v>
                  </c:pt>
                </c:numCache>
              </c:numRef>
            </c:minus>
          </c:errBars>
          <c:cat>
            <c:strRef>
              <c:f>Sheet1!$AY$153:$AY$160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Sheet1!$BB$153:$BB$160</c:f>
              <c:numCache>
                <c:formatCode>General</c:formatCode>
                <c:ptCount val="8"/>
                <c:pt idx="0">
                  <c:v>0.0</c:v>
                </c:pt>
                <c:pt idx="1">
                  <c:v>0.606734279863362</c:v>
                </c:pt>
                <c:pt idx="2">
                  <c:v>4.95086130669337</c:v>
                </c:pt>
                <c:pt idx="3">
                  <c:v>4.760055857929402</c:v>
                </c:pt>
                <c:pt idx="4">
                  <c:v>69.6086948212282</c:v>
                </c:pt>
                <c:pt idx="5">
                  <c:v>15.35808156647866</c:v>
                </c:pt>
                <c:pt idx="6">
                  <c:v>4.153231551862357</c:v>
                </c:pt>
                <c:pt idx="7">
                  <c:v>0.5623406159446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8638760"/>
        <c:axId val="-2138526296"/>
      </c:barChart>
      <c:catAx>
        <c:axId val="-2138638760"/>
        <c:scaling>
          <c:orientation val="minMax"/>
        </c:scaling>
        <c:delete val="0"/>
        <c:axPos val="b"/>
        <c:majorTickMark val="out"/>
        <c:minorTickMark val="none"/>
        <c:tickLblPos val="nextTo"/>
        <c:crossAx val="-2138526296"/>
        <c:crosses val="autoZero"/>
        <c:auto val="1"/>
        <c:lblAlgn val="ctr"/>
        <c:lblOffset val="100"/>
        <c:noMultiLvlLbl val="0"/>
      </c:catAx>
      <c:valAx>
        <c:axId val="-2138526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2138638760"/>
        <c:crosses val="autoZero"/>
        <c:crossBetween val="between"/>
      </c:valAx>
    </c:plotArea>
    <c:legend>
      <c:legendPos val="l"/>
      <c:layout>
        <c:manualLayout>
          <c:xMode val="edge"/>
          <c:yMode val="edge"/>
          <c:x val="0.171296296296296"/>
          <c:y val="0.103426290463692"/>
          <c:w val="0.270505978419364"/>
          <c:h val="0.272314085739283"/>
        </c:manualLayout>
      </c:layout>
      <c:overlay val="1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F20453-7EBD-B84B-BE6E-CF8F9A7D3EF7}" type="datetimeFigureOut">
              <a:rPr lang="en-US" smtClean="0"/>
              <a:t>1/11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FDA13F-EDC1-0649-94BE-EDBBAAF47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7663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987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676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270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858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32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315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037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026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85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251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294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501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1" name="Chart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0301323"/>
              </p:ext>
            </p:extLst>
          </p:nvPr>
        </p:nvGraphicFramePr>
        <p:xfrm>
          <a:off x="692150" y="5392415"/>
          <a:ext cx="27432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8" name="Chart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4701710"/>
              </p:ext>
            </p:extLst>
          </p:nvPr>
        </p:nvGraphicFramePr>
        <p:xfrm>
          <a:off x="3474827" y="1426491"/>
          <a:ext cx="27432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92151" y="1232754"/>
            <a:ext cx="6647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CDTA</a:t>
            </a:r>
            <a:endParaRPr 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461563" y="1232752"/>
            <a:ext cx="164747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odium Carbonate</a:t>
            </a:r>
          </a:p>
          <a:p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780566" y="3314604"/>
            <a:ext cx="87491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1M KOH</a:t>
            </a:r>
          </a:p>
          <a:p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474827" y="3314606"/>
            <a:ext cx="874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4M KOH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819038" y="5267842"/>
            <a:ext cx="6649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Pellet</a:t>
            </a:r>
          </a:p>
        </p:txBody>
      </p:sp>
      <p:sp>
        <p:nvSpPr>
          <p:cNvPr id="2" name="TextBox 1"/>
          <p:cNvSpPr txBox="1"/>
          <p:nvPr/>
        </p:nvSpPr>
        <p:spPr>
          <a:xfrm rot="16200000">
            <a:off x="3190096" y="3873339"/>
            <a:ext cx="569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ol</a:t>
            </a:r>
            <a:r>
              <a:rPr lang="en-US" sz="1200" dirty="0" smtClean="0"/>
              <a:t>%</a:t>
            </a:r>
            <a:endParaRPr lang="en-US" sz="12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3176831" y="1932982"/>
            <a:ext cx="569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ol</a:t>
            </a:r>
            <a:r>
              <a:rPr lang="en-US" sz="1200" dirty="0" smtClean="0"/>
              <a:t>%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455834" y="3873338"/>
            <a:ext cx="569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ol</a:t>
            </a:r>
            <a:r>
              <a:rPr lang="en-US" sz="1200" dirty="0" smtClean="0"/>
              <a:t>%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413964" y="1891117"/>
            <a:ext cx="569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ol</a:t>
            </a:r>
            <a:r>
              <a:rPr lang="en-US" sz="1200" dirty="0" smtClean="0"/>
              <a:t>%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413965" y="5965481"/>
            <a:ext cx="569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ol</a:t>
            </a:r>
            <a:r>
              <a:rPr lang="en-US" sz="1200" dirty="0" smtClean="0"/>
              <a:t>%</a:t>
            </a:r>
            <a:endParaRPr lang="en-US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1918245" y="2117454"/>
            <a:ext cx="274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2759738" y="1426491"/>
            <a:ext cx="274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1647041" y="2269382"/>
            <a:ext cx="274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1363682" y="2276248"/>
            <a:ext cx="274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697679" y="1554601"/>
            <a:ext cx="274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5535879" y="1578891"/>
            <a:ext cx="274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2765482" y="4258942"/>
            <a:ext cx="274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graphicFrame>
        <p:nvGraphicFramePr>
          <p:cNvPr id="27" name="Char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8359726"/>
              </p:ext>
            </p:extLst>
          </p:nvPr>
        </p:nvGraphicFramePr>
        <p:xfrm>
          <a:off x="692150" y="1554601"/>
          <a:ext cx="2743200" cy="16039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9" name="Chart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6039299"/>
              </p:ext>
            </p:extLst>
          </p:nvPr>
        </p:nvGraphicFramePr>
        <p:xfrm>
          <a:off x="692150" y="3406937"/>
          <a:ext cx="27432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0" name="Char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7240617"/>
              </p:ext>
            </p:extLst>
          </p:nvPr>
        </p:nvGraphicFramePr>
        <p:xfrm>
          <a:off x="3474827" y="3406937"/>
          <a:ext cx="27432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811688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5</Words>
  <Application>Microsoft Macintosh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JBE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lomon Stonebloom</dc:creator>
  <cp:lastModifiedBy>Solomon Stonebloom</cp:lastModifiedBy>
  <cp:revision>11</cp:revision>
  <dcterms:created xsi:type="dcterms:W3CDTF">2016-01-11T20:47:51Z</dcterms:created>
  <dcterms:modified xsi:type="dcterms:W3CDTF">2016-01-11T20:55:43Z</dcterms:modified>
</cp:coreProperties>
</file>